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AD5697-97F8-468B-92CD-198542C7315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B59189-45E6-4954-9A35-8BFDFCBC3EB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4DDD37-5F7E-433D-A63C-63E9A1FE658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6EAB54-FA62-4AF1-99D6-B48B869CB9C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C7DE23-012F-48AC-A20C-AD8E7C3AEF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834187-A9D6-48B6-A8AC-0AACE63A43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50F7AE-E7D9-4776-9F66-DE4914165B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C2BA71-3915-428A-B42E-F14C59087B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AAFCB3-E4C9-464B-917E-1372C334B0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8B901B-BCA7-4C0A-B07D-37888B4038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821E9C-36DB-4F7B-943A-0C5B8938CB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AC8FB1-9F56-4790-800E-D579B2977C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7B81371-81C1-4EBA-9CB5-ED26C245166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12"/>
          <p:cNvGraphicFramePr/>
          <p:nvPr/>
        </p:nvGraphicFramePr>
        <p:xfrm>
          <a:off x="1547640" y="533520"/>
          <a:ext cx="6034320" cy="41907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Object 1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547640" y="533520"/>
                    <a:ext cx="6034320" cy="4190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TextBox 5"/>
          <p:cNvSpPr/>
          <p:nvPr/>
        </p:nvSpPr>
        <p:spPr>
          <a:xfrm>
            <a:off x="717480" y="4952880"/>
            <a:ext cx="7696440" cy="67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Comparative real-time PCR analysis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cry1A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transcript in T</a:t>
            </a:r>
            <a:r>
              <a:rPr b="0" lang="en-US" sz="1200" spc="-1" strike="noStrike" baseline="-30000">
                <a:solidFill>
                  <a:srgbClr val="000000"/>
                </a:solidFill>
                <a:latin typeface="Times New Roman"/>
                <a:ea typeface="Calibri"/>
              </a:rPr>
              <a:t>0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plants showing fold change in expression with respect to the low expressing transgenic plant Ab2. Control: non-transformed plant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Dr D V Amla</dc:creator>
  <dc:description/>
  <dc:language>en-US</dc:language>
  <cp:lastModifiedBy> </cp:lastModifiedBy>
  <dcterms:modified xsi:type="dcterms:W3CDTF">2014-01-28T12:45:24Z</dcterms:modified>
  <cp:revision>4</cp:revision>
  <dc:subject/>
  <dc:title>Slide 1</dc:title>
</cp:coreProperties>
</file>